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66F3713-AF5C-EE41-91A1-B8B6E7C32133}" v="1" dt="2024-11-08T16:54:04.88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726"/>
  </p:normalViewPr>
  <p:slideViewPr>
    <p:cSldViewPr snapToGrid="0">
      <p:cViewPr varScale="1">
        <p:scale>
          <a:sx n="120" d="100"/>
          <a:sy n="120" d="100"/>
        </p:scale>
        <p:origin x="7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u, Dongyu /US" userId="9c65d386-3d04-4cb3-a539-2d21b4ae6b07" providerId="ADAL" clId="{566F3713-AF5C-EE41-91A1-B8B6E7C32133}"/>
    <pc:docChg chg="delSld modSld">
      <pc:chgData name="Liu, Dongyu /US" userId="9c65d386-3d04-4cb3-a539-2d21b4ae6b07" providerId="ADAL" clId="{566F3713-AF5C-EE41-91A1-B8B6E7C32133}" dt="2024-11-15T01:27:07.818" v="39" actId="20577"/>
      <pc:docMkLst>
        <pc:docMk/>
      </pc:docMkLst>
      <pc:sldChg chg="addSp modSp mod">
        <pc:chgData name="Liu, Dongyu /US" userId="9c65d386-3d04-4cb3-a539-2d21b4ae6b07" providerId="ADAL" clId="{566F3713-AF5C-EE41-91A1-B8B6E7C32133}" dt="2024-11-15T01:27:07.818" v="39" actId="20577"/>
        <pc:sldMkLst>
          <pc:docMk/>
          <pc:sldMk cId="2950774528" sldId="256"/>
        </pc:sldMkLst>
        <pc:spChg chg="add mod">
          <ac:chgData name="Liu, Dongyu /US" userId="9c65d386-3d04-4cb3-a539-2d21b4ae6b07" providerId="ADAL" clId="{566F3713-AF5C-EE41-91A1-B8B6E7C32133}" dt="2024-11-15T01:27:07.818" v="39" actId="20577"/>
          <ac:spMkLst>
            <pc:docMk/>
            <pc:sldMk cId="2950774528" sldId="256"/>
            <ac:spMk id="3" creationId="{06B12266-BB98-3519-DCD1-4FA9348BEB33}"/>
          </ac:spMkLst>
        </pc:spChg>
        <pc:spChg chg="add mod">
          <ac:chgData name="Liu, Dongyu /US" userId="9c65d386-3d04-4cb3-a539-2d21b4ae6b07" providerId="ADAL" clId="{566F3713-AF5C-EE41-91A1-B8B6E7C32133}" dt="2024-11-08T16:54:48.953" v="33" actId="1076"/>
          <ac:spMkLst>
            <pc:docMk/>
            <pc:sldMk cId="2950774528" sldId="256"/>
            <ac:spMk id="6" creationId="{F988FB01-2F42-07D0-DCC0-9368CC6112C7}"/>
          </ac:spMkLst>
        </pc:spChg>
        <pc:spChg chg="add mod">
          <ac:chgData name="Liu, Dongyu /US" userId="9c65d386-3d04-4cb3-a539-2d21b4ae6b07" providerId="ADAL" clId="{566F3713-AF5C-EE41-91A1-B8B6E7C32133}" dt="2024-11-08T16:54:51.637" v="34" actId="1076"/>
          <ac:spMkLst>
            <pc:docMk/>
            <pc:sldMk cId="2950774528" sldId="256"/>
            <ac:spMk id="8" creationId="{55F9FAD6-06BE-0EDE-163A-BB5FAD31899F}"/>
          </ac:spMkLst>
        </pc:spChg>
        <pc:spChg chg="mod">
          <ac:chgData name="Liu, Dongyu /US" userId="9c65d386-3d04-4cb3-a539-2d21b4ae6b07" providerId="ADAL" clId="{566F3713-AF5C-EE41-91A1-B8B6E7C32133}" dt="2024-11-08T16:53:10.320" v="12" actId="21"/>
          <ac:spMkLst>
            <pc:docMk/>
            <pc:sldMk cId="2950774528" sldId="256"/>
            <ac:spMk id="19" creationId="{2F1CD550-4209-F676-E00D-3582E91A6B88}"/>
          </ac:spMkLst>
        </pc:spChg>
      </pc:sldChg>
      <pc:sldChg chg="del">
        <pc:chgData name="Liu, Dongyu /US" userId="9c65d386-3d04-4cb3-a539-2d21b4ae6b07" providerId="ADAL" clId="{566F3713-AF5C-EE41-91A1-B8B6E7C32133}" dt="2024-11-08T16:52:08.535" v="0" actId="2696"/>
        <pc:sldMkLst>
          <pc:docMk/>
          <pc:sldMk cId="384675688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15136D-6E97-E9DA-F62F-C985D76121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498A6C-B1CC-0143-82CE-4741E75BA3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76D01B-0C85-F177-D5BC-B94BCAF8C9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3AA5B8-9F44-E929-3AF1-41A863991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5F386C-19A7-6063-DEF8-C109E4D487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321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5B0909-CB66-2B56-4E07-99792CA329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4C356B-22B1-D3B9-E987-448C863B4F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7FFABC-1065-4EF8-EC49-81909BF33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B2EC16-223B-33B5-1A8E-7CC927743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B82589-AD15-DE53-3B11-43EB3DCC3C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612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0E95F1-043B-0373-E182-EDE7A20FA4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BEDEDC-979D-267D-51B2-C656DC5EDF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9BF984-5F6B-AFFC-88B5-ABABAED1AB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242B94-4D00-2EBC-A2B1-7A26F0795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403FF8-1D83-9DF4-400E-F3B5C4E7B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760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1DF4B6-CC3E-65D6-364B-CFCA586081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486353-D1CE-E8B7-E95C-778014B1DA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348667-A494-E9E3-E11E-A540B030D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39E2CE-1969-F698-8976-B1A9DDA59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A23F02-5902-5DDB-2FD5-9E5B413D32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233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D644EF-325A-D62B-8066-A5E01EA00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4DBA72-84CB-DB7E-3994-B6350FECA2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91ED37-6EEE-455E-FC25-E6D57D19A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E54DB4-311D-B03C-502F-E7534B88F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D72F15-196D-E4E3-3A1A-9AE9748CB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397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A369B3-3092-2A1F-6910-20FAEB1306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8FA742-4582-D9B9-C13A-6A7DEF0468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9A4663-C867-5928-E909-B1B78F8DAC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0FE36E-B12C-D1F8-CEEA-372F1B5AD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185DA4-4B37-5180-9860-EC5848443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A8C1F9-9DD0-1936-101B-0A0A6C6B7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397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C9954-9DFE-7E98-1001-B3B9FEF74B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1825ED-6C9D-9BC5-E1C7-E2018BD688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678616-ADE0-6833-903E-B40F44B4AA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0F738F5-7A57-8F17-3908-E5E82DB8C8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1606AC-65A1-AD43-CD52-A5EC444272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8D8E8A-83D2-EEAA-76FB-88A1CC8016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FA8FF0E-6C98-FEEC-F89B-C43EC53AE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40A5C4-3090-DA0B-391E-E3154C989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624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63964-27CB-091D-64E0-E79F5821C6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39AAB8-5A10-D693-2AAE-BD4416DD5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94331A3-DF5A-4C24-133C-21B1D8F91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319CC1-DA45-A04E-90FB-F6F1F3DD6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561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84CE56F-7EF3-E65C-AA07-310FFDD49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46A729E-A4EF-93D3-4290-44138D674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D3B0F5-561B-63CE-1918-C073978C5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555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0DBE4-DC23-FD32-4B5F-F2F1A68945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7587DF-1258-0913-4F72-265EAFB94F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4399AD-0C36-6449-B44A-EEF9780C10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79ABCD-51F0-DE33-974C-07317AD13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C2EFE3-CB33-5886-638A-F05679949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CF6F71-7A5F-8FA1-9CF1-0B40DB9C4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742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B7C776-FEB7-3B79-195F-9D0651BBF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57389B-2075-DF55-7DD0-B8BA47EA44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D68D70-0FA0-8C1B-6757-1014D7847A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FFF04C-7B0C-85D7-6B86-F80474D1A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542069-1D0A-2216-F20B-18BA86957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AEEAA4-ACE4-F5B6-005D-B49F39E62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483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62CA04C-B6D8-4244-981F-6A018E61C0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D20FCB-3338-A6C4-94D1-1B14A77DB1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032250-5559-3B77-343A-AE46F758E2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976EE54-1CCF-E443-A465-865A5296C09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1BCB05-83EA-95F3-24FC-053C0E09C8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19D1A7-70C4-A158-FD72-DCE3C9A32D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AC1EEF-1C59-714E-8964-9C4FC71912EA}" type="slidenum">
              <a:rPr lang="en-US" smtClean="0"/>
              <a:t>‹#›</a:t>
            </a:fld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7A018BF-F7B0-4FCE-EBFE-6C2F43DDC4C8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5893562" y="63500"/>
            <a:ext cx="433388" cy="15240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en-US" sz="1000">
                <a:solidFill>
                  <a:srgbClr val="4A569E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</a:t>
            </a:r>
          </a:p>
        </p:txBody>
      </p:sp>
    </p:spTree>
    <p:extLst>
      <p:ext uri="{BB962C8B-B14F-4D97-AF65-F5344CB8AC3E}">
        <p14:creationId xmlns:p14="http://schemas.microsoft.com/office/powerpoint/2010/main" val="3400872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with blue and orange dots&#10;&#10;Description automatically generated">
            <a:extLst>
              <a:ext uri="{FF2B5EF4-FFF2-40B4-BE49-F238E27FC236}">
                <a16:creationId xmlns:a16="http://schemas.microsoft.com/office/drawing/2014/main" id="{19EBA59B-7BE5-D589-FBFB-9EE5B6063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3460" y="1490100"/>
            <a:ext cx="3804865" cy="2316929"/>
          </a:xfrm>
          <a:prstGeom prst="rect">
            <a:avLst/>
          </a:prstGeom>
        </p:spPr>
      </p:pic>
      <p:pic>
        <p:nvPicPr>
          <p:cNvPr id="7" name="Picture 6" descr="A graph with blue dots and numbers&#10;&#10;Description automatically generated">
            <a:extLst>
              <a:ext uri="{FF2B5EF4-FFF2-40B4-BE49-F238E27FC236}">
                <a16:creationId xmlns:a16="http://schemas.microsoft.com/office/drawing/2014/main" id="{83E78500-469D-8B92-FCFD-DDB25BEB7F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6790" y="1490100"/>
            <a:ext cx="3804866" cy="2316929"/>
          </a:xfrm>
          <a:prstGeom prst="rect">
            <a:avLst/>
          </a:prstGeom>
        </p:spPr>
      </p:pic>
      <p:pic>
        <p:nvPicPr>
          <p:cNvPr id="9" name="Picture 8" descr="A graph with blue and orange dots&#10;&#10;Description automatically generated">
            <a:extLst>
              <a:ext uri="{FF2B5EF4-FFF2-40B4-BE49-F238E27FC236}">
                <a16:creationId xmlns:a16="http://schemas.microsoft.com/office/drawing/2014/main" id="{EB5FDE91-25C8-4D71-ACB6-A3C07954BD5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19167" y="1377424"/>
            <a:ext cx="3973136" cy="2419396"/>
          </a:xfrm>
          <a:prstGeom prst="rect">
            <a:avLst/>
          </a:prstGeom>
        </p:spPr>
      </p:pic>
      <p:pic>
        <p:nvPicPr>
          <p:cNvPr id="11" name="Picture 10" descr="A graph with blue and orange dots&#10;&#10;Description automatically generated">
            <a:extLst>
              <a:ext uri="{FF2B5EF4-FFF2-40B4-BE49-F238E27FC236}">
                <a16:creationId xmlns:a16="http://schemas.microsoft.com/office/drawing/2014/main" id="{40D4B96C-6E10-B8D9-4740-D5BFE60B98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3855" y="4094827"/>
            <a:ext cx="3943936" cy="2401614"/>
          </a:xfrm>
          <a:prstGeom prst="rect">
            <a:avLst/>
          </a:prstGeom>
        </p:spPr>
      </p:pic>
      <p:pic>
        <p:nvPicPr>
          <p:cNvPr id="13" name="Picture 12" descr="A graph with blue and orange dots&#10;&#10;Description automatically generated">
            <a:extLst>
              <a:ext uri="{FF2B5EF4-FFF2-40B4-BE49-F238E27FC236}">
                <a16:creationId xmlns:a16="http://schemas.microsoft.com/office/drawing/2014/main" id="{6F2A5D0D-B352-809C-D1A5-1FC134457DB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22783" y="4094827"/>
            <a:ext cx="3943936" cy="2401614"/>
          </a:xfrm>
          <a:prstGeom prst="rect">
            <a:avLst/>
          </a:prstGeom>
        </p:spPr>
      </p:pic>
      <p:pic>
        <p:nvPicPr>
          <p:cNvPr id="15" name="Picture 14" descr="A graph with blue and orange dots&#10;&#10;Description automatically generated">
            <a:extLst>
              <a:ext uri="{FF2B5EF4-FFF2-40B4-BE49-F238E27FC236}">
                <a16:creationId xmlns:a16="http://schemas.microsoft.com/office/drawing/2014/main" id="{66DD1CDD-892F-9325-4FE5-43EC783A096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046067" y="4094827"/>
            <a:ext cx="3943936" cy="2401614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2F1CD550-4209-F676-E00D-3582E91A6B88}"/>
              </a:ext>
            </a:extLst>
          </p:cNvPr>
          <p:cNvSpPr txBox="1"/>
          <p:nvPr/>
        </p:nvSpPr>
        <p:spPr>
          <a:xfrm>
            <a:off x="241738" y="78353"/>
            <a:ext cx="1131791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SEAPreranked</a:t>
            </a:r>
            <a:r>
              <a:rPr lang="en-US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sults of disease associated genes ranked by </a:t>
            </a:r>
            <a:r>
              <a:rPr lang="en-US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iLinker</a:t>
            </a:r>
            <a:r>
              <a:rPr lang="en-US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core vs ranked by cooccurrence counts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6B12266-BB98-3519-DCD1-4FA9348BEB33}"/>
              </a:ext>
            </a:extLst>
          </p:cNvPr>
          <p:cNvSpPr txBox="1"/>
          <p:nvPr/>
        </p:nvSpPr>
        <p:spPr>
          <a:xfrm>
            <a:off x="293460" y="739684"/>
            <a:ext cx="1119508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gene sets are the four clinically validated disease target groups (phase 1, phase 2, phase 3 and approved). The markers are colored by </a:t>
            </a:r>
            <a:r>
              <a:rPr lang="en-US" sz="16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FDR</a:t>
            </a:r>
            <a:endParaRPr lang="en-US" sz="16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988FB01-2F42-07D0-DCC0-9368CC6112C7}"/>
              </a:ext>
            </a:extLst>
          </p:cNvPr>
          <p:cNvSpPr txBox="1"/>
          <p:nvPr/>
        </p:nvSpPr>
        <p:spPr>
          <a:xfrm>
            <a:off x="4858127" y="6502648"/>
            <a:ext cx="22021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 – Rheumatoid arthriti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5F9FAD6-06BE-0EDE-163A-BB5FAD31899F}"/>
              </a:ext>
            </a:extLst>
          </p:cNvPr>
          <p:cNvSpPr txBox="1"/>
          <p:nvPr/>
        </p:nvSpPr>
        <p:spPr>
          <a:xfrm>
            <a:off x="9124379" y="6517449"/>
            <a:ext cx="178731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C – Ulcerative Colitis</a:t>
            </a:r>
          </a:p>
        </p:txBody>
      </p:sp>
    </p:spTree>
    <p:extLst>
      <p:ext uri="{BB962C8B-B14F-4D97-AF65-F5344CB8AC3E}">
        <p14:creationId xmlns:p14="http://schemas.microsoft.com/office/powerpoint/2010/main" val="2950774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58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u, Dongyu /US</dc:creator>
  <cp:lastModifiedBy>Liu, Dongyu /US</cp:lastModifiedBy>
  <cp:revision>1</cp:revision>
  <dcterms:created xsi:type="dcterms:W3CDTF">2024-10-29T18:15:09Z</dcterms:created>
  <dcterms:modified xsi:type="dcterms:W3CDTF">2024-11-15T01:27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9e3dcb88-8425-4e1d-b1a3-bd5572915bbc_Enabled">
    <vt:lpwstr>true</vt:lpwstr>
  </property>
  <property fmtid="{D5CDD505-2E9C-101B-9397-08002B2CF9AE}" pid="3" name="MSIP_Label_9e3dcb88-8425-4e1d-b1a3-bd5572915bbc_SetDate">
    <vt:lpwstr>2024-10-29T18:20:02Z</vt:lpwstr>
  </property>
  <property fmtid="{D5CDD505-2E9C-101B-9397-08002B2CF9AE}" pid="4" name="MSIP_Label_9e3dcb88-8425-4e1d-b1a3-bd5572915bbc_Method">
    <vt:lpwstr>Privileged</vt:lpwstr>
  </property>
  <property fmtid="{D5CDD505-2E9C-101B-9397-08002B2CF9AE}" pid="5" name="MSIP_Label_9e3dcb88-8425-4e1d-b1a3-bd5572915bbc_Name">
    <vt:lpwstr>Internal</vt:lpwstr>
  </property>
  <property fmtid="{D5CDD505-2E9C-101B-9397-08002B2CF9AE}" pid="6" name="MSIP_Label_9e3dcb88-8425-4e1d-b1a3-bd5572915bbc_SiteId">
    <vt:lpwstr>aca3c8d6-aa71-4e1a-a10e-03572fc58c0b</vt:lpwstr>
  </property>
  <property fmtid="{D5CDD505-2E9C-101B-9397-08002B2CF9AE}" pid="7" name="MSIP_Label_9e3dcb88-8425-4e1d-b1a3-bd5572915bbc_ActionId">
    <vt:lpwstr>9ebb7eb0-96c9-481d-bb86-e7d2633f398d</vt:lpwstr>
  </property>
  <property fmtid="{D5CDD505-2E9C-101B-9397-08002B2CF9AE}" pid="8" name="MSIP_Label_9e3dcb88-8425-4e1d-b1a3-bd5572915bbc_ContentBits">
    <vt:lpwstr>1</vt:lpwstr>
  </property>
  <property fmtid="{D5CDD505-2E9C-101B-9397-08002B2CF9AE}" pid="9" name="ClassificationContentMarkingHeaderLocations">
    <vt:lpwstr>Office Theme:8</vt:lpwstr>
  </property>
  <property fmtid="{D5CDD505-2E9C-101B-9397-08002B2CF9AE}" pid="10" name="ClassificationContentMarkingHeaderText">
    <vt:lpwstr>Internal</vt:lpwstr>
  </property>
</Properties>
</file>